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567"/>
  </p:normalViewPr>
  <p:slideViewPr>
    <p:cSldViewPr snapToGrid="0" snapToObjects="1">
      <p:cViewPr varScale="1">
        <p:scale>
          <a:sx n="63" d="100"/>
          <a:sy n="63" d="100"/>
        </p:scale>
        <p:origin x="29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D8D79-FA78-394F-920D-CAAF760DE691}" type="datetimeFigureOut">
              <a:rPr lang="en-US" smtClean="0"/>
              <a:t>3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AE721F-0019-5D4B-950E-0C5CF3AFA5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719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C25EFE4-12C1-2749-8406-BB4C3AB4B613}"/>
              </a:ext>
            </a:extLst>
          </p:cNvPr>
          <p:cNvSpPr txBox="1"/>
          <p:nvPr/>
        </p:nvSpPr>
        <p:spPr>
          <a:xfrm>
            <a:off x="0" y="8138159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Percentage binding of polyclonal antibodies to ZIKV antigen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Untransduced K562 cells and K562 cells expressing ZIKV E ectodomain, prM or NS1 on their surface were incubated with 45 dpi mouse serum at IgG concentration of 0.5 and 1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mL</a:t>
            </a:r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Alexa Fluor 647-conjugated secondary antibody was used to quantify binding to ZIKV antigens by flow cytometry. Gating was done based on secondary antibody only control. 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28482" y="9629001"/>
            <a:ext cx="24272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. Figure 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5_Lee 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et al., 2020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6D735566-2949-1940-B956-66EDBA53DB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61399"/>
            <a:ext cx="6858000" cy="75123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7796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</TotalTime>
  <Words>82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ryl Lee</dc:creator>
  <cp:lastModifiedBy>CHERYL</cp:lastModifiedBy>
  <cp:revision>18</cp:revision>
  <cp:lastPrinted>2018-12-13T01:49:50Z</cp:lastPrinted>
  <dcterms:created xsi:type="dcterms:W3CDTF">2018-12-11T07:01:46Z</dcterms:created>
  <dcterms:modified xsi:type="dcterms:W3CDTF">2020-03-15T15:40:35Z</dcterms:modified>
</cp:coreProperties>
</file>